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1" y="43200"/>
            <a:ext cx="8172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Effect of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KN) on the cell cycle of synovial fibroblasts.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035696" y="537539"/>
            <a:ext cx="5676016" cy="4823772"/>
            <a:chOff x="696184" y="1403484"/>
            <a:chExt cx="5676016" cy="4823772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00670" y="4032696"/>
              <a:ext cx="2194560" cy="219456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01147" y="4032696"/>
              <a:ext cx="2194560" cy="219456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74720" y="1666488"/>
              <a:ext cx="2194560" cy="219456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71600" y="1666488"/>
              <a:ext cx="2194560" cy="219456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700957" y="1403484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187145" y="1403484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690265" y="1403484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96184" y="3882384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182372" y="3923764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762273" y="3882384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矩形 2"/>
          <p:cNvSpPr/>
          <p:nvPr/>
        </p:nvSpPr>
        <p:spPr>
          <a:xfrm>
            <a:off x="323528" y="5528763"/>
            <a:ext cx="849694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NF-α is 0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B, The concentration of TNF-α is 20 ng/mL; C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0.2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NF-α is 20 ng/mL; D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0.05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0.1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0.2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BCFC5E54-4CCD-4711-AE32-D37DAA0EC8B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5773" y="776087"/>
            <a:ext cx="2194560" cy="219456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86230D58-AA02-4CD6-AB55-CD6454D6519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748" y="3138099"/>
            <a:ext cx="2194560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6575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92</Words>
  <Application>Microsoft Office PowerPoint</Application>
  <PresentationFormat>全屏显示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anhua</cp:lastModifiedBy>
  <cp:revision>33</cp:revision>
  <dcterms:created xsi:type="dcterms:W3CDTF">2021-04-28T07:20:05Z</dcterms:created>
  <dcterms:modified xsi:type="dcterms:W3CDTF">2021-09-12T01:33:57Z</dcterms:modified>
</cp:coreProperties>
</file>